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0" r:id="rId4"/>
    <p:sldId id="261" r:id="rId5"/>
    <p:sldId id="259" r:id="rId6"/>
    <p:sldId id="265" r:id="rId7"/>
    <p:sldId id="266" r:id="rId8"/>
    <p:sldId id="267" r:id="rId9"/>
    <p:sldId id="264" r:id="rId10"/>
    <p:sldId id="272" r:id="rId11"/>
    <p:sldId id="273" r:id="rId12"/>
    <p:sldId id="274" r:id="rId13"/>
    <p:sldId id="270" r:id="rId14"/>
    <p:sldId id="277" r:id="rId15"/>
    <p:sldId id="278" r:id="rId16"/>
    <p:sldId id="279" r:id="rId17"/>
    <p:sldId id="276" r:id="rId18"/>
    <p:sldId id="283" r:id="rId19"/>
    <p:sldId id="284" r:id="rId20"/>
    <p:sldId id="286" r:id="rId21"/>
    <p:sldId id="282" r:id="rId22"/>
    <p:sldId id="293" r:id="rId23"/>
    <p:sldId id="291" r:id="rId24"/>
    <p:sldId id="290" r:id="rId25"/>
    <p:sldId id="288" r:id="rId26"/>
    <p:sldId id="295" r:id="rId27"/>
    <p:sldId id="296" r:id="rId28"/>
    <p:sldId id="298" r:id="rId29"/>
    <p:sldId id="294" r:id="rId30"/>
    <p:sldId id="307" r:id="rId31"/>
    <p:sldId id="309" r:id="rId32"/>
    <p:sldId id="310" r:id="rId33"/>
    <p:sldId id="308" r:id="rId3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34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360" y="5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presProps" Target="presProps.xml"/><Relationship Id="rId8" Type="http://schemas.openxmlformats.org/officeDocument/2006/relationships/slide" Target="slides/slide7.xml"/><Relationship Id="rId3" Type="http://schemas.openxmlformats.org/officeDocument/2006/relationships/slide" Target="slides/slide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9866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700759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18188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6557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8254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16731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985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3279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7007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7014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9AAC8D-5E44-48F9-B640-0B9C0B294AAB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5755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9AAC8D-5E44-48F9-B640-0B9C0B294AAB}" type="datetimeFigureOut">
              <a:rPr lang="ko-KR" altLang="en-US" smtClean="0"/>
              <a:t>2024-09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5C9348-6461-4D28-B5A5-734873F73CA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0200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26" Type="http://schemas.openxmlformats.org/officeDocument/2006/relationships/image" Target="../media/image23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microsoft.com/office/2007/relationships/hdphoto" Target="../media/hdphoto2.wdp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2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1.png"/><Relationship Id="rId28" Type="http://schemas.microsoft.com/office/2007/relationships/hdphoto" Target="../media/hdphoto3.wdp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microsoft.com/office/2007/relationships/hdphoto" Target="../media/hdphoto1.wdp"/><Relationship Id="rId27" Type="http://schemas.openxmlformats.org/officeDocument/2006/relationships/image" Target="../media/image24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png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2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/>
          <p:cNvSpPr txBox="1"/>
          <p:nvPr/>
        </p:nvSpPr>
        <p:spPr>
          <a:xfrm>
            <a:off x="1673735" y="-360707"/>
            <a:ext cx="2716779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i="1" dirty="0">
                <a:latin typeface="Arial" panose="020B0604020202020204" pitchFamily="34" charset="0"/>
                <a:cs typeface="Arial" panose="020B0604020202020204" pitchFamily="34" charset="0"/>
              </a:rPr>
              <a:t>Aldh1l1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-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551003" y="-360707"/>
            <a:ext cx="2716779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 / </a:t>
            </a:r>
            <a:r>
              <a:rPr lang="en-US" altLang="ko-KR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FP</a:t>
            </a:r>
            <a:endParaRPr lang="ko-KR" altLang="en-US" b="1" dirty="0">
              <a:solidFill>
                <a:srgbClr val="FF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6200000">
            <a:off x="-2366845" y="791065"/>
            <a:ext cx="16272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6.5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-2366845" y="2571771"/>
            <a:ext cx="16272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7.5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 rot="16200000">
            <a:off x="-2365887" y="4354051"/>
            <a:ext cx="16272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8.5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 rot="16200000">
            <a:off x="-2366846" y="6133180"/>
            <a:ext cx="1627200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0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-1203533" y="-360707"/>
            <a:ext cx="2716779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H2B Tag-R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-1203534" y="-822105"/>
            <a:ext cx="8469162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mpty vector (Control)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 rot="16200000">
            <a:off x="-5537942" y="3462123"/>
            <a:ext cx="6969315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 err="1">
                <a:latin typeface="Arial" panose="020B0604020202020204" pitchFamily="34" charset="0"/>
                <a:cs typeface="Arial" panose="020B0604020202020204" pitchFamily="34" charset="0"/>
              </a:rPr>
              <a:t>EPed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 at E15.5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7" name="그림 4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1195179" y="160557"/>
            <a:ext cx="2714625" cy="1628775"/>
          </a:xfrm>
          <a:prstGeom prst="rect">
            <a:avLst/>
          </a:prstGeom>
        </p:spPr>
      </p:pic>
      <p:cxnSp>
        <p:nvCxnSpPr>
          <p:cNvPr id="49" name="직선 연결선 48"/>
          <p:cNvCxnSpPr/>
          <p:nvPr/>
        </p:nvCxnSpPr>
        <p:spPr>
          <a:xfrm>
            <a:off x="-1131679" y="276446"/>
            <a:ext cx="777600" cy="8165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0" name="그림 4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77912" y="160556"/>
            <a:ext cx="2714625" cy="1628775"/>
          </a:xfrm>
          <a:prstGeom prst="rect">
            <a:avLst/>
          </a:prstGeom>
        </p:spPr>
      </p:pic>
      <p:pic>
        <p:nvPicPr>
          <p:cNvPr id="51" name="그림 5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51003" y="160556"/>
            <a:ext cx="2714625" cy="1628775"/>
          </a:xfrm>
          <a:prstGeom prst="rect">
            <a:avLst/>
          </a:prstGeom>
        </p:spPr>
      </p:pic>
      <p:pic>
        <p:nvPicPr>
          <p:cNvPr id="52" name="그림 5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39027" y="160555"/>
            <a:ext cx="2714625" cy="1628775"/>
          </a:xfrm>
          <a:prstGeom prst="rect">
            <a:avLst/>
          </a:prstGeom>
        </p:spPr>
      </p:pic>
      <p:pic>
        <p:nvPicPr>
          <p:cNvPr id="54" name="그림 5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185209" y="160556"/>
            <a:ext cx="2714625" cy="1628775"/>
          </a:xfrm>
          <a:prstGeom prst="rect">
            <a:avLst/>
          </a:prstGeom>
        </p:spPr>
      </p:pic>
      <p:pic>
        <p:nvPicPr>
          <p:cNvPr id="56" name="그림 5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312117" y="160555"/>
            <a:ext cx="2714625" cy="1628775"/>
          </a:xfrm>
          <a:prstGeom prst="rect">
            <a:avLst/>
          </a:prstGeom>
        </p:spPr>
      </p:pic>
      <p:sp>
        <p:nvSpPr>
          <p:cNvPr id="57" name="TextBox 56"/>
          <p:cNvSpPr txBox="1"/>
          <p:nvPr/>
        </p:nvSpPr>
        <p:spPr>
          <a:xfrm>
            <a:off x="10316296" y="-360707"/>
            <a:ext cx="2716779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i="1" dirty="0">
                <a:latin typeface="Arial" panose="020B0604020202020204" pitchFamily="34" charset="0"/>
                <a:cs typeface="Arial" panose="020B0604020202020204" pitchFamily="34" charset="0"/>
              </a:rPr>
              <a:t>Aldh1l1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-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3193564" y="-360707"/>
            <a:ext cx="2716779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 / </a:t>
            </a:r>
            <a:r>
              <a:rPr lang="en-US" altLang="ko-KR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FP</a:t>
            </a:r>
            <a:endParaRPr lang="ko-KR" altLang="en-US" b="1" dirty="0">
              <a:solidFill>
                <a:srgbClr val="FF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7439028" y="-360707"/>
            <a:ext cx="2716779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H2B Tag-R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7439027" y="-822105"/>
            <a:ext cx="8469162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18Ink4c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2" name="그림 6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551001" y="1941263"/>
            <a:ext cx="2714625" cy="1628775"/>
          </a:xfrm>
          <a:prstGeom prst="rect">
            <a:avLst/>
          </a:prstGeom>
        </p:spPr>
      </p:pic>
      <p:pic>
        <p:nvPicPr>
          <p:cNvPr id="63" name="그림 6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-1195179" y="1941263"/>
            <a:ext cx="2714625" cy="1628775"/>
          </a:xfrm>
          <a:prstGeom prst="rect">
            <a:avLst/>
          </a:prstGeom>
        </p:spPr>
      </p:pic>
      <p:pic>
        <p:nvPicPr>
          <p:cNvPr id="64" name="그림 6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677909" y="1941262"/>
            <a:ext cx="2714625" cy="1628775"/>
          </a:xfrm>
          <a:prstGeom prst="rect">
            <a:avLst/>
          </a:prstGeom>
        </p:spPr>
      </p:pic>
      <p:pic>
        <p:nvPicPr>
          <p:cNvPr id="66" name="그림 65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3185209" y="1941260"/>
            <a:ext cx="2714625" cy="1628775"/>
          </a:xfrm>
          <a:prstGeom prst="rect">
            <a:avLst/>
          </a:prstGeom>
        </p:spPr>
      </p:pic>
      <p:pic>
        <p:nvPicPr>
          <p:cNvPr id="67" name="그림 66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439025" y="1941260"/>
            <a:ext cx="2714625" cy="1628775"/>
          </a:xfrm>
          <a:prstGeom prst="rect">
            <a:avLst/>
          </a:prstGeom>
        </p:spPr>
      </p:pic>
      <p:pic>
        <p:nvPicPr>
          <p:cNvPr id="68" name="그림 67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0312117" y="1955541"/>
            <a:ext cx="2714625" cy="1628775"/>
          </a:xfrm>
          <a:prstGeom prst="rect">
            <a:avLst/>
          </a:prstGeom>
        </p:spPr>
      </p:pic>
      <p:pic>
        <p:nvPicPr>
          <p:cNvPr id="70" name="그림 69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3185209" y="3699531"/>
            <a:ext cx="2714625" cy="1628775"/>
          </a:xfrm>
          <a:prstGeom prst="rect">
            <a:avLst/>
          </a:prstGeom>
        </p:spPr>
      </p:pic>
      <p:pic>
        <p:nvPicPr>
          <p:cNvPr id="71" name="그림 7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439025" y="3721964"/>
            <a:ext cx="2714625" cy="1628775"/>
          </a:xfrm>
          <a:prstGeom prst="rect">
            <a:avLst/>
          </a:prstGeom>
        </p:spPr>
      </p:pic>
      <p:pic>
        <p:nvPicPr>
          <p:cNvPr id="72" name="그림 71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0312117" y="3721964"/>
            <a:ext cx="2714625" cy="1628775"/>
          </a:xfrm>
          <a:prstGeom prst="rect">
            <a:avLst/>
          </a:prstGeom>
        </p:spPr>
      </p:pic>
      <p:pic>
        <p:nvPicPr>
          <p:cNvPr id="74" name="그림 73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565933" y="3721964"/>
            <a:ext cx="2714625" cy="1628775"/>
          </a:xfrm>
          <a:prstGeom prst="rect">
            <a:avLst/>
          </a:prstGeom>
        </p:spPr>
      </p:pic>
      <p:pic>
        <p:nvPicPr>
          <p:cNvPr id="75" name="그림 74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-1180251" y="3736246"/>
            <a:ext cx="2714625" cy="1628775"/>
          </a:xfrm>
          <a:prstGeom prst="rect">
            <a:avLst/>
          </a:prstGeom>
        </p:spPr>
      </p:pic>
      <p:pic>
        <p:nvPicPr>
          <p:cNvPr id="76" name="그림 75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692841" y="3736238"/>
            <a:ext cx="2714625" cy="1628775"/>
          </a:xfrm>
          <a:prstGeom prst="rect">
            <a:avLst/>
          </a:prstGeom>
        </p:spPr>
      </p:pic>
      <p:pic>
        <p:nvPicPr>
          <p:cNvPr id="78" name="그림 77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551001" y="5502665"/>
            <a:ext cx="2714625" cy="1628775"/>
          </a:xfrm>
          <a:prstGeom prst="rect">
            <a:avLst/>
          </a:prstGeom>
        </p:spPr>
      </p:pic>
      <p:pic>
        <p:nvPicPr>
          <p:cNvPr id="79" name="그림 78"/>
          <p:cNvPicPr>
            <a:picLocks noChangeAspect="1"/>
          </p:cNvPicPr>
          <p:nvPr/>
        </p:nvPicPr>
        <p:blipFill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-1195185" y="5502665"/>
            <a:ext cx="2714625" cy="1628775"/>
          </a:xfrm>
          <a:prstGeom prst="rect">
            <a:avLst/>
          </a:prstGeom>
        </p:spPr>
      </p:pic>
      <p:pic>
        <p:nvPicPr>
          <p:cNvPr id="80" name="그림 79"/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1677908" y="5502664"/>
            <a:ext cx="2714625" cy="1628775"/>
          </a:xfrm>
          <a:prstGeom prst="rect">
            <a:avLst/>
          </a:prstGeom>
        </p:spPr>
      </p:pic>
      <p:pic>
        <p:nvPicPr>
          <p:cNvPr id="82" name="그림 81"/>
          <p:cNvPicPr>
            <a:picLocks noChangeAspect="1"/>
          </p:cNvPicPr>
          <p:nvPr/>
        </p:nvPicPr>
        <p:blipFill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3170279" y="5502665"/>
            <a:ext cx="2714625" cy="1628775"/>
          </a:xfrm>
          <a:prstGeom prst="rect">
            <a:avLst/>
          </a:prstGeom>
        </p:spPr>
      </p:pic>
      <p:pic>
        <p:nvPicPr>
          <p:cNvPr id="83" name="그림 82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7447377" y="5502665"/>
            <a:ext cx="2714625" cy="1628775"/>
          </a:xfrm>
          <a:prstGeom prst="rect">
            <a:avLst/>
          </a:prstGeom>
        </p:spPr>
      </p:pic>
      <p:pic>
        <p:nvPicPr>
          <p:cNvPr id="84" name="그림 83"/>
          <p:cNvPicPr>
            <a:picLocks noChangeAspect="1"/>
          </p:cNvPicPr>
          <p:nvPr/>
        </p:nvPicPr>
        <p:blipFill>
          <a:blip r:embed="rId27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297187" y="5502664"/>
            <a:ext cx="2714625" cy="1628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38646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205164">
            <a:off x="2698750" y="-118213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979923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205164">
            <a:off x="2698750" y="-118213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918172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205164">
            <a:off x="2698750" y="-118213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082252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9207" y="1814508"/>
            <a:ext cx="2714625" cy="162877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7_c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331778" y="1245155"/>
            <a:ext cx="1629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H2B Tag R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460531" y="124515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613087" y="124515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1852707" y="1930400"/>
            <a:ext cx="777600" cy="8165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35387" y="1814508"/>
            <a:ext cx="2714625" cy="1628775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62295" y="1814507"/>
            <a:ext cx="2714625" cy="1628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520693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41324">
            <a:off x="4502152" y="133350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828519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41324">
            <a:off x="4502153" y="133351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642206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41324">
            <a:off x="4502153" y="133351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704009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9203" y="1814506"/>
            <a:ext cx="2714625" cy="162877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7_p18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331778" y="1245155"/>
            <a:ext cx="1629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H2B Tag R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460531" y="124515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613087" y="124515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1852707" y="1930400"/>
            <a:ext cx="777600" cy="8165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그림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35387" y="1814506"/>
            <a:ext cx="2714625" cy="1628775"/>
          </a:xfrm>
          <a:prstGeom prst="rect">
            <a:avLst/>
          </a:prstGeom>
        </p:spPr>
      </p:pic>
      <p:pic>
        <p:nvPicPr>
          <p:cNvPr id="14" name="그림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62295" y="1828787"/>
            <a:ext cx="2714625" cy="1628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946707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925645">
            <a:off x="3282951" y="-717550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626535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925645">
            <a:off x="3292476" y="-717550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88071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38337">
            <a:off x="4692649" y="-361949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862326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925645">
            <a:off x="3292476" y="-717550"/>
            <a:ext cx="5895975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4870584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9203" y="1828787"/>
            <a:ext cx="2714625" cy="162877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8_con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331778" y="1245155"/>
            <a:ext cx="1629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H2B Tag R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460531" y="124515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613087" y="124515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1852707" y="1930400"/>
            <a:ext cx="777600" cy="8165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35387" y="1814505"/>
            <a:ext cx="2714625" cy="1628775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62295" y="1828779"/>
            <a:ext cx="2714625" cy="1628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041989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381429">
            <a:off x="3600449" y="-1189264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0652478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381429">
            <a:off x="3600449" y="-1189264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6106176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381429">
            <a:off x="3600449" y="-1189264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796935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9203" y="1851211"/>
            <a:ext cx="2714625" cy="162877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8_p18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331778" y="1245155"/>
            <a:ext cx="1629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H2B Tag R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460531" y="124515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613087" y="124515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1852707" y="1930400"/>
            <a:ext cx="777600" cy="8165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그림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35387" y="1828778"/>
            <a:ext cx="2714625" cy="1628775"/>
          </a:xfrm>
          <a:prstGeom prst="rect">
            <a:avLst/>
          </a:prstGeom>
        </p:spPr>
      </p:pic>
      <p:pic>
        <p:nvPicPr>
          <p:cNvPr id="14" name="그림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62295" y="1851211"/>
            <a:ext cx="2714625" cy="1628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99173314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944862">
            <a:off x="4298949" y="-654049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7295382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944862">
            <a:off x="4298949" y="-654049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649117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0944862">
            <a:off x="4298949" y="-654049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3483225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9201" y="1851211"/>
            <a:ext cx="2714625" cy="162877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0_con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331778" y="1245155"/>
            <a:ext cx="1629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H2B Tag R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460531" y="124515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613087" y="124515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1852707" y="1930400"/>
            <a:ext cx="777600" cy="8165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그림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35387" y="1851211"/>
            <a:ext cx="2714625" cy="1628775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62294" y="1851210"/>
            <a:ext cx="2714625" cy="1628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361762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38337">
            <a:off x="4694917" y="-361949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9891243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>
            <a:extLst>
              <a:ext uri="{FF2B5EF4-FFF2-40B4-BE49-F238E27FC236}">
                <a16:creationId xmlns:a16="http://schemas.microsoft.com/office/drawing/2014/main" id="{6AED27D4-DE44-6235-3D72-A6E2B957687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72883">
            <a:off x="3093811" y="354239"/>
            <a:ext cx="5772150" cy="577215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3360724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28A531DD-503F-5E50-511F-FF47B8E184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72883">
            <a:off x="3093811" y="354239"/>
            <a:ext cx="5772150" cy="577215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74430205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D4F84971-258A-87B7-6E5E-F241030B66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72883">
            <a:off x="3093811" y="354239"/>
            <a:ext cx="5772150" cy="577215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15936937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26303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P0_p18_revise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331778" y="1245155"/>
            <a:ext cx="1629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H2B Tag R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460531" y="124515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613087" y="124515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1852707" y="1930400"/>
            <a:ext cx="777600" cy="8165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그림 2">
            <a:extLst>
              <a:ext uri="{FF2B5EF4-FFF2-40B4-BE49-F238E27FC236}">
                <a16:creationId xmlns:a16="http://schemas.microsoft.com/office/drawing/2014/main" id="{156145A8-9CFA-AA70-D068-1620B81ADE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9199" y="1853736"/>
            <a:ext cx="2714400" cy="1626248"/>
          </a:xfrm>
          <a:prstGeom prst="rect">
            <a:avLst/>
          </a:prstGeom>
        </p:spPr>
      </p:pic>
      <p:pic>
        <p:nvPicPr>
          <p:cNvPr id="10" name="그림 9">
            <a:extLst>
              <a:ext uri="{FF2B5EF4-FFF2-40B4-BE49-F238E27FC236}">
                <a16:creationId xmlns:a16="http://schemas.microsoft.com/office/drawing/2014/main" id="{7C811407-4C14-8916-3B21-E4803488F8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62408" y="1852061"/>
            <a:ext cx="2714400" cy="1627923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3F5390A0-BF30-459B-B1B5-6D51B14A189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35500" y="1852061"/>
            <a:ext cx="2714400" cy="16279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56564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38337">
            <a:off x="4692649" y="-361949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6078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9207" y="1814511"/>
            <a:ext cx="2714625" cy="162877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6_c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331778" y="1245155"/>
            <a:ext cx="1629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H2B Tag R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460531" y="124515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613087" y="124515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1852707" y="1930400"/>
            <a:ext cx="777600" cy="8165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그림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62298" y="1814510"/>
            <a:ext cx="2714625" cy="1628775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35389" y="1814510"/>
            <a:ext cx="2714625" cy="1628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190489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439077">
            <a:off x="2393949" y="-107950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61459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439077">
            <a:off x="2393949" y="-98425"/>
            <a:ext cx="5905500" cy="5895975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50877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439077">
            <a:off x="2393949" y="-107950"/>
            <a:ext cx="5905500" cy="5905500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653643" y="1992086"/>
            <a:ext cx="3600450" cy="2155371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488729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89207" y="1814509"/>
            <a:ext cx="2714625" cy="1628775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6_p18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331778" y="1245155"/>
            <a:ext cx="1629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H2B Tag R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460531" y="1245155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613087" y="1245155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GFP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1852707" y="1930400"/>
            <a:ext cx="777600" cy="8165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그림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35389" y="1814510"/>
            <a:ext cx="2714625" cy="1628775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62297" y="1814509"/>
            <a:ext cx="2714625" cy="1628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43917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3</TotalTime>
  <Words>91</Words>
  <Application>Microsoft Office PowerPoint</Application>
  <PresentationFormat>와이드스크린</PresentationFormat>
  <Paragraphs>45</Paragraphs>
  <Slides>3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3</vt:i4>
      </vt:variant>
    </vt:vector>
  </HeadingPairs>
  <TitlesOfParts>
    <vt:vector size="36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kbri</dc:creator>
  <cp:lastModifiedBy>이 원영</cp:lastModifiedBy>
  <cp:revision>16</cp:revision>
  <dcterms:created xsi:type="dcterms:W3CDTF">2019-01-29T05:34:41Z</dcterms:created>
  <dcterms:modified xsi:type="dcterms:W3CDTF">2024-09-27T02:37:12Z</dcterms:modified>
</cp:coreProperties>
</file>